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8016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88" userDrawn="1">
          <p15:clr>
            <a:srgbClr val="A4A3A4"/>
          </p15:clr>
        </p15:guide>
        <p15:guide id="2" pos="4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0E53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5" autoAdjust="0"/>
    <p:restoredTop sz="94660"/>
  </p:normalViewPr>
  <p:slideViewPr>
    <p:cSldViewPr snapToGrid="0" showGuides="1">
      <p:cViewPr>
        <p:scale>
          <a:sx n="95" d="100"/>
          <a:sy n="95" d="100"/>
        </p:scale>
        <p:origin x="-390" y="-1620"/>
      </p:cViewPr>
      <p:guideLst>
        <p:guide orient="horz" pos="1488"/>
        <p:guide pos="4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00200" y="1272011"/>
            <a:ext cx="9601200" cy="2705947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4082310"/>
            <a:ext cx="9601200" cy="1876530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739C1-CD65-45E4-9EA0-F1F524AF9997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7B098-049E-46B9-81C2-E80CD6398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687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739C1-CD65-45E4-9EA0-F1F524AF9997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7B098-049E-46B9-81C2-E80CD6398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997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5" y="413808"/>
            <a:ext cx="2760345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0" y="413808"/>
            <a:ext cx="8121015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739C1-CD65-45E4-9EA0-F1F524AF9997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7B098-049E-46B9-81C2-E80CD6398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434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739C1-CD65-45E4-9EA0-F1F524AF9997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7B098-049E-46B9-81C2-E80CD6398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203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1937704"/>
            <a:ext cx="11041380" cy="3233102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5201392"/>
            <a:ext cx="11041380" cy="1700212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739C1-CD65-45E4-9EA0-F1F524AF9997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7B098-049E-46B9-81C2-E80CD6398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9047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2069042"/>
            <a:ext cx="544068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2069042"/>
            <a:ext cx="544068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739C1-CD65-45E4-9EA0-F1F524AF9997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7B098-049E-46B9-81C2-E80CD6398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741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413809"/>
            <a:ext cx="1104138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8" y="1905318"/>
            <a:ext cx="5415676" cy="933767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8" y="2839085"/>
            <a:ext cx="5415676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0" y="1905318"/>
            <a:ext cx="5442347" cy="933767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0" y="2839085"/>
            <a:ext cx="5442347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739C1-CD65-45E4-9EA0-F1F524AF9997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7B098-049E-46B9-81C2-E80CD6398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222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739C1-CD65-45E4-9EA0-F1F524AF9997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7B098-049E-46B9-81C2-E80CD6398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780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739C1-CD65-45E4-9EA0-F1F524AF9997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7B098-049E-46B9-81C2-E80CD6398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958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518160"/>
            <a:ext cx="4128849" cy="181356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119082"/>
            <a:ext cx="6480810" cy="5523442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331720"/>
            <a:ext cx="4128849" cy="4319800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739C1-CD65-45E4-9EA0-F1F524AF9997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7B098-049E-46B9-81C2-E80CD6398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053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518160"/>
            <a:ext cx="4128849" cy="181356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119082"/>
            <a:ext cx="6480810" cy="5523442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331720"/>
            <a:ext cx="4128849" cy="4319800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739C1-CD65-45E4-9EA0-F1F524AF9997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7B098-049E-46B9-81C2-E80CD6398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411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413809"/>
            <a:ext cx="1104138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2069042"/>
            <a:ext cx="1104138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7203864"/>
            <a:ext cx="288036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739C1-CD65-45E4-9EA0-F1F524AF9997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7203864"/>
            <a:ext cx="43205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7203864"/>
            <a:ext cx="288036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87B098-049E-46B9-81C2-E80CD63982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946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C6E034D-5F3F-4A82-9429-55262EFE555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87" t="6321" r="587"/>
          <a:stretch/>
        </p:blipFill>
        <p:spPr>
          <a:xfrm>
            <a:off x="446568" y="473294"/>
            <a:ext cx="3629749" cy="212669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A15EB5D-F3B5-4420-93EF-0929EA9EF52D}"/>
              </a:ext>
            </a:extLst>
          </p:cNvPr>
          <p:cNvSpPr txBox="1"/>
          <p:nvPr/>
        </p:nvSpPr>
        <p:spPr>
          <a:xfrm>
            <a:off x="1307805" y="272632"/>
            <a:ext cx="15744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iological sex: all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0B06B5A4-187C-4978-B872-6E33DD4C688B}"/>
              </a:ext>
            </a:extLst>
          </p:cNvPr>
          <p:cNvGrpSpPr/>
          <p:nvPr/>
        </p:nvGrpSpPr>
        <p:grpSpPr>
          <a:xfrm>
            <a:off x="851390" y="2698330"/>
            <a:ext cx="2773449" cy="442382"/>
            <a:chOff x="1709644" y="3216584"/>
            <a:chExt cx="2773449" cy="442382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56B98115-2277-45E2-B290-5F1A1AEB9546}"/>
                </a:ext>
              </a:extLst>
            </p:cNvPr>
            <p:cNvGrpSpPr/>
            <p:nvPr/>
          </p:nvGrpSpPr>
          <p:grpSpPr>
            <a:xfrm>
              <a:off x="2187295" y="3216584"/>
              <a:ext cx="2295798" cy="184654"/>
              <a:chOff x="2187295" y="3009014"/>
              <a:chExt cx="2295798" cy="184654"/>
            </a:xfrm>
          </p:grpSpPr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41267E3B-4A36-445F-AB83-260D8D9AE192}"/>
                  </a:ext>
                </a:extLst>
              </p:cNvPr>
              <p:cNvCxnSpPr/>
              <p:nvPr/>
            </p:nvCxnSpPr>
            <p:spPr>
              <a:xfrm>
                <a:off x="2187295" y="3099676"/>
                <a:ext cx="137160" cy="0"/>
              </a:xfrm>
              <a:prstGeom prst="line">
                <a:avLst/>
              </a:prstGeom>
              <a:ln w="15875">
                <a:solidFill>
                  <a:srgbClr val="90E53B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089B6382-BB39-4C7E-885A-6D3E857940F4}"/>
                  </a:ext>
                </a:extLst>
              </p:cNvPr>
              <p:cNvGrpSpPr/>
              <p:nvPr/>
            </p:nvGrpSpPr>
            <p:grpSpPr>
              <a:xfrm>
                <a:off x="2276834" y="3009014"/>
                <a:ext cx="2206259" cy="184654"/>
                <a:chOff x="2248785" y="3009014"/>
                <a:chExt cx="2206259" cy="184654"/>
              </a:xfrm>
            </p:grpSpPr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F8A4DD2B-DDFA-49D1-95F0-64FC558B02CE}"/>
                    </a:ext>
                  </a:extLst>
                </p:cNvPr>
                <p:cNvSpPr txBox="1"/>
                <p:nvPr/>
              </p:nvSpPr>
              <p:spPr>
                <a:xfrm>
                  <a:off x="2248785" y="3009014"/>
                  <a:ext cx="2206259" cy="1846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A (n = 252)  Median 12.75 months (95% CI: 11.83 – 14.6)</a:t>
                  </a:r>
                </a:p>
              </p:txBody>
            </p:sp>
            <p:cxnSp>
              <p:nvCxnSpPr>
                <p:cNvPr id="18" name="Straight Connector 17">
                  <a:extLst>
                    <a:ext uri="{FF2B5EF4-FFF2-40B4-BE49-F238E27FC236}">
                      <a16:creationId xmlns:a16="http://schemas.microsoft.com/office/drawing/2014/main" id="{C206A266-5B91-4840-BF11-EA828AE81DA0}"/>
                    </a:ext>
                  </a:extLst>
                </p:cNvPr>
                <p:cNvCxnSpPr/>
                <p:nvPr/>
              </p:nvCxnSpPr>
              <p:spPr>
                <a:xfrm>
                  <a:off x="2788212" y="3054796"/>
                  <a:ext cx="0" cy="91440"/>
                </a:xfrm>
                <a:prstGeom prst="line">
                  <a:avLst/>
                </a:prstGeom>
                <a:ln w="63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39566814-2CA7-4737-AA31-FC5B3521B50E}"/>
                </a:ext>
              </a:extLst>
            </p:cNvPr>
            <p:cNvGrpSpPr/>
            <p:nvPr/>
          </p:nvGrpSpPr>
          <p:grpSpPr>
            <a:xfrm>
              <a:off x="2188539" y="3349255"/>
              <a:ext cx="2211215" cy="184652"/>
              <a:chOff x="2188539" y="3349255"/>
              <a:chExt cx="2211215" cy="184652"/>
            </a:xfrm>
          </p:grpSpPr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E41C215D-75E7-4A58-9DC9-50FF9D8C0130}"/>
                  </a:ext>
                </a:extLst>
              </p:cNvPr>
              <p:cNvCxnSpPr/>
              <p:nvPr/>
            </p:nvCxnSpPr>
            <p:spPr>
              <a:xfrm>
                <a:off x="2188539" y="3436666"/>
                <a:ext cx="137160" cy="0"/>
              </a:xfrm>
              <a:prstGeom prst="line">
                <a:avLst/>
              </a:prstGeom>
              <a:ln w="15875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68433BAD-E6B8-45CD-8AE1-097F272DD997}"/>
                  </a:ext>
                </a:extLst>
              </p:cNvPr>
              <p:cNvGrpSpPr/>
              <p:nvPr/>
            </p:nvGrpSpPr>
            <p:grpSpPr>
              <a:xfrm>
                <a:off x="2276836" y="3349255"/>
                <a:ext cx="2122918" cy="184652"/>
                <a:chOff x="2248785" y="3349255"/>
                <a:chExt cx="2122918" cy="184652"/>
              </a:xfrm>
            </p:grpSpPr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D750513D-AE87-4AD2-97CD-7196F73AFFDE}"/>
                    </a:ext>
                  </a:extLst>
                </p:cNvPr>
                <p:cNvSpPr txBox="1"/>
                <p:nvPr/>
              </p:nvSpPr>
              <p:spPr>
                <a:xfrm>
                  <a:off x="2248785" y="3349255"/>
                  <a:ext cx="2122918" cy="18465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G (n = 76)  Median 12.73 months (95% CI: 10.43 – 16)</a:t>
                  </a:r>
                </a:p>
              </p:txBody>
            </p:sp>
            <p:cxnSp>
              <p:nvCxnSpPr>
                <p:cNvPr id="21" name="Straight Connector 20">
                  <a:extLst>
                    <a:ext uri="{FF2B5EF4-FFF2-40B4-BE49-F238E27FC236}">
                      <a16:creationId xmlns:a16="http://schemas.microsoft.com/office/drawing/2014/main" id="{A281CC07-F29E-4659-9C22-740262F91A16}"/>
                    </a:ext>
                  </a:extLst>
                </p:cNvPr>
                <p:cNvCxnSpPr/>
                <p:nvPr/>
              </p:nvCxnSpPr>
              <p:spPr>
                <a:xfrm>
                  <a:off x="2757190" y="3389727"/>
                  <a:ext cx="0" cy="91440"/>
                </a:xfrm>
                <a:prstGeom prst="line">
                  <a:avLst/>
                </a:prstGeom>
                <a:ln w="63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8F74214B-3DAA-4ED6-B957-B433077798F2}"/>
                </a:ext>
              </a:extLst>
            </p:cNvPr>
            <p:cNvGrpSpPr/>
            <p:nvPr/>
          </p:nvGrpSpPr>
          <p:grpSpPr>
            <a:xfrm>
              <a:off x="2187642" y="3474300"/>
              <a:ext cx="2291016" cy="184666"/>
              <a:chOff x="2187642" y="3659427"/>
              <a:chExt cx="2291016" cy="184666"/>
            </a:xfrm>
          </p:grpSpPr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FD8ACD12-760B-4965-89B4-6C392A3FD57E}"/>
                  </a:ext>
                </a:extLst>
              </p:cNvPr>
              <p:cNvCxnSpPr/>
              <p:nvPr/>
            </p:nvCxnSpPr>
            <p:spPr>
              <a:xfrm>
                <a:off x="2187642" y="3742360"/>
                <a:ext cx="137160" cy="0"/>
              </a:xfrm>
              <a:prstGeom prst="lin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76266358-EB6B-47A7-B114-716C4AD1A169}"/>
                  </a:ext>
                </a:extLst>
              </p:cNvPr>
              <p:cNvGrpSpPr/>
              <p:nvPr/>
            </p:nvGrpSpPr>
            <p:grpSpPr>
              <a:xfrm>
                <a:off x="2272398" y="3659427"/>
                <a:ext cx="2206260" cy="184666"/>
                <a:chOff x="2227518" y="3659427"/>
                <a:chExt cx="2206260" cy="184666"/>
              </a:xfrm>
            </p:grpSpPr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1733169C-EDF5-4C72-8743-EBACA5F97E42}"/>
                    </a:ext>
                  </a:extLst>
                </p:cNvPr>
                <p:cNvSpPr txBox="1"/>
                <p:nvPr/>
              </p:nvSpPr>
              <p:spPr>
                <a:xfrm>
                  <a:off x="2227518" y="3659427"/>
                  <a:ext cx="220626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G (n = 163)  Median 12.5 months (95% CI: 10.8 – 14.07)</a:t>
                  </a:r>
                </a:p>
              </p:txBody>
            </p:sp>
            <p:cxnSp>
              <p:nvCxnSpPr>
                <p:cNvPr id="22" name="Straight Connector 21">
                  <a:extLst>
                    <a:ext uri="{FF2B5EF4-FFF2-40B4-BE49-F238E27FC236}">
                      <a16:creationId xmlns:a16="http://schemas.microsoft.com/office/drawing/2014/main" id="{102659D4-5173-44A0-9322-BBFA4F1A29E2}"/>
                    </a:ext>
                  </a:extLst>
                </p:cNvPr>
                <p:cNvCxnSpPr/>
                <p:nvPr/>
              </p:nvCxnSpPr>
              <p:spPr>
                <a:xfrm>
                  <a:off x="2785958" y="3706335"/>
                  <a:ext cx="0" cy="91440"/>
                </a:xfrm>
                <a:prstGeom prst="line">
                  <a:avLst/>
                </a:prstGeom>
                <a:ln w="63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1FED88E-DA7D-4DF7-9057-5DF902225EFE}"/>
                </a:ext>
              </a:extLst>
            </p:cNvPr>
            <p:cNvSpPr txBox="1"/>
            <p:nvPr/>
          </p:nvSpPr>
          <p:spPr>
            <a:xfrm>
              <a:off x="1709644" y="3352701"/>
              <a:ext cx="52206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Genotype</a:t>
              </a:r>
            </a:p>
          </p:txBody>
        </p:sp>
      </p:grpSp>
      <p:pic>
        <p:nvPicPr>
          <p:cNvPr id="32" name="Picture 31">
            <a:extLst>
              <a:ext uri="{FF2B5EF4-FFF2-40B4-BE49-F238E27FC236}">
                <a16:creationId xmlns:a16="http://schemas.microsoft.com/office/drawing/2014/main" id="{ED0AA3C1-7BCC-4DD9-B127-0DA0FC103F9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17" t="5874" r="751"/>
          <a:stretch/>
        </p:blipFill>
        <p:spPr>
          <a:xfrm>
            <a:off x="4676775" y="473294"/>
            <a:ext cx="3514725" cy="2133601"/>
          </a:xfrm>
          <a:prstGeom prst="rect">
            <a:avLst/>
          </a:prstGeom>
        </p:spPr>
      </p:pic>
      <p:grpSp>
        <p:nvGrpSpPr>
          <p:cNvPr id="33" name="Group 32">
            <a:extLst>
              <a:ext uri="{FF2B5EF4-FFF2-40B4-BE49-F238E27FC236}">
                <a16:creationId xmlns:a16="http://schemas.microsoft.com/office/drawing/2014/main" id="{5BC9C857-C6BE-446A-9E9F-269C730E7C83}"/>
              </a:ext>
            </a:extLst>
          </p:cNvPr>
          <p:cNvGrpSpPr/>
          <p:nvPr/>
        </p:nvGrpSpPr>
        <p:grpSpPr>
          <a:xfrm>
            <a:off x="5013782" y="2691071"/>
            <a:ext cx="2773449" cy="442382"/>
            <a:chOff x="1709644" y="3216584"/>
            <a:chExt cx="2773449" cy="442382"/>
          </a:xfrm>
        </p:grpSpPr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46293739-B3E3-44E2-B6B2-1F65B94CCA80}"/>
                </a:ext>
              </a:extLst>
            </p:cNvPr>
            <p:cNvGrpSpPr/>
            <p:nvPr/>
          </p:nvGrpSpPr>
          <p:grpSpPr>
            <a:xfrm>
              <a:off x="2187295" y="3216584"/>
              <a:ext cx="2295798" cy="184654"/>
              <a:chOff x="2187295" y="3009014"/>
              <a:chExt cx="2295798" cy="184654"/>
            </a:xfrm>
          </p:grpSpPr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id="{8F5F83F9-60D7-4A33-9CD7-8C02E53229AE}"/>
                  </a:ext>
                </a:extLst>
              </p:cNvPr>
              <p:cNvCxnSpPr/>
              <p:nvPr/>
            </p:nvCxnSpPr>
            <p:spPr>
              <a:xfrm>
                <a:off x="2187295" y="3099676"/>
                <a:ext cx="137160" cy="0"/>
              </a:xfrm>
              <a:prstGeom prst="line">
                <a:avLst/>
              </a:prstGeom>
              <a:ln w="15875">
                <a:solidFill>
                  <a:srgbClr val="90E53B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7" name="Group 46">
                <a:extLst>
                  <a:ext uri="{FF2B5EF4-FFF2-40B4-BE49-F238E27FC236}">
                    <a16:creationId xmlns:a16="http://schemas.microsoft.com/office/drawing/2014/main" id="{5DECDEE7-D3D0-4251-9053-FEF8CD7087E0}"/>
                  </a:ext>
                </a:extLst>
              </p:cNvPr>
              <p:cNvGrpSpPr/>
              <p:nvPr/>
            </p:nvGrpSpPr>
            <p:grpSpPr>
              <a:xfrm>
                <a:off x="2276834" y="3009014"/>
                <a:ext cx="2206259" cy="184654"/>
                <a:chOff x="2248785" y="3009014"/>
                <a:chExt cx="2206259" cy="184654"/>
              </a:xfrm>
            </p:grpSpPr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7A08AEA0-8C4B-48C1-802E-75B4DD841EED}"/>
                    </a:ext>
                  </a:extLst>
                </p:cNvPr>
                <p:cNvSpPr txBox="1"/>
                <p:nvPr/>
              </p:nvSpPr>
              <p:spPr>
                <a:xfrm>
                  <a:off x="2248785" y="3009014"/>
                  <a:ext cx="2206259" cy="1846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A (n = 153)  Median 13.47 months (95% CI: 11.9 – 14.73)</a:t>
                  </a:r>
                </a:p>
              </p:txBody>
            </p:sp>
            <p:cxnSp>
              <p:nvCxnSpPr>
                <p:cNvPr id="49" name="Straight Connector 48">
                  <a:extLst>
                    <a:ext uri="{FF2B5EF4-FFF2-40B4-BE49-F238E27FC236}">
                      <a16:creationId xmlns:a16="http://schemas.microsoft.com/office/drawing/2014/main" id="{C39928C8-B886-41C2-87E7-2BB14CD882A0}"/>
                    </a:ext>
                  </a:extLst>
                </p:cNvPr>
                <p:cNvCxnSpPr/>
                <p:nvPr/>
              </p:nvCxnSpPr>
              <p:spPr>
                <a:xfrm>
                  <a:off x="2788212" y="3054796"/>
                  <a:ext cx="0" cy="91440"/>
                </a:xfrm>
                <a:prstGeom prst="line">
                  <a:avLst/>
                </a:prstGeom>
                <a:ln w="63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A0EBF5C1-9DC0-4BC4-93C7-E8872B0E8D13}"/>
                </a:ext>
              </a:extLst>
            </p:cNvPr>
            <p:cNvGrpSpPr/>
            <p:nvPr/>
          </p:nvGrpSpPr>
          <p:grpSpPr>
            <a:xfrm>
              <a:off x="2188539" y="3349255"/>
              <a:ext cx="2211215" cy="184652"/>
              <a:chOff x="2188539" y="3349255"/>
              <a:chExt cx="2211215" cy="184652"/>
            </a:xfrm>
          </p:grpSpPr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D9B3B31B-3401-40F2-B7D6-55D99E9CA152}"/>
                  </a:ext>
                </a:extLst>
              </p:cNvPr>
              <p:cNvCxnSpPr/>
              <p:nvPr/>
            </p:nvCxnSpPr>
            <p:spPr>
              <a:xfrm>
                <a:off x="2188539" y="3436666"/>
                <a:ext cx="137160" cy="0"/>
              </a:xfrm>
              <a:prstGeom prst="line">
                <a:avLst/>
              </a:prstGeom>
              <a:ln w="15875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936F6624-4988-4888-BCB6-D8D50C3EFA92}"/>
                  </a:ext>
                </a:extLst>
              </p:cNvPr>
              <p:cNvGrpSpPr/>
              <p:nvPr/>
            </p:nvGrpSpPr>
            <p:grpSpPr>
              <a:xfrm>
                <a:off x="2276836" y="3349255"/>
                <a:ext cx="2122918" cy="184652"/>
                <a:chOff x="2248785" y="3349255"/>
                <a:chExt cx="2122918" cy="184652"/>
              </a:xfrm>
            </p:grpSpPr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6A65CD49-688A-455C-972B-E92249B3B67C}"/>
                    </a:ext>
                  </a:extLst>
                </p:cNvPr>
                <p:cNvSpPr txBox="1"/>
                <p:nvPr/>
              </p:nvSpPr>
              <p:spPr>
                <a:xfrm>
                  <a:off x="2248785" y="3349255"/>
                  <a:ext cx="2122918" cy="18465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G (n = 51)  Median 12 months (95% CI: 7.7 – 15.63)</a:t>
                  </a:r>
                </a:p>
              </p:txBody>
            </p:sp>
            <p:cxnSp>
              <p:nvCxnSpPr>
                <p:cNvPr id="45" name="Straight Connector 44">
                  <a:extLst>
                    <a:ext uri="{FF2B5EF4-FFF2-40B4-BE49-F238E27FC236}">
                      <a16:creationId xmlns:a16="http://schemas.microsoft.com/office/drawing/2014/main" id="{D098E257-55F5-4A35-A9CF-F5FFD88AD351}"/>
                    </a:ext>
                  </a:extLst>
                </p:cNvPr>
                <p:cNvCxnSpPr/>
                <p:nvPr/>
              </p:nvCxnSpPr>
              <p:spPr>
                <a:xfrm>
                  <a:off x="2757190" y="3389727"/>
                  <a:ext cx="0" cy="91440"/>
                </a:xfrm>
                <a:prstGeom prst="line">
                  <a:avLst/>
                </a:prstGeom>
                <a:ln w="63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B9C0C8EC-DE29-4EB9-B266-0BCBA12C45BE}"/>
                </a:ext>
              </a:extLst>
            </p:cNvPr>
            <p:cNvGrpSpPr/>
            <p:nvPr/>
          </p:nvGrpSpPr>
          <p:grpSpPr>
            <a:xfrm>
              <a:off x="2187642" y="3474300"/>
              <a:ext cx="2291016" cy="184666"/>
              <a:chOff x="2187642" y="3659427"/>
              <a:chExt cx="2291016" cy="184666"/>
            </a:xfrm>
          </p:grpSpPr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F487B512-F528-4570-AAEE-653B0B64ABA5}"/>
                  </a:ext>
                </a:extLst>
              </p:cNvPr>
              <p:cNvCxnSpPr/>
              <p:nvPr/>
            </p:nvCxnSpPr>
            <p:spPr>
              <a:xfrm>
                <a:off x="2187642" y="3742360"/>
                <a:ext cx="137160" cy="0"/>
              </a:xfrm>
              <a:prstGeom prst="lin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7E549AA8-16F9-477D-9AE5-FC67ED9E55CC}"/>
                  </a:ext>
                </a:extLst>
              </p:cNvPr>
              <p:cNvGrpSpPr/>
              <p:nvPr/>
            </p:nvGrpSpPr>
            <p:grpSpPr>
              <a:xfrm>
                <a:off x="2272398" y="3659427"/>
                <a:ext cx="2206260" cy="184666"/>
                <a:chOff x="2227518" y="3659427"/>
                <a:chExt cx="2206260" cy="184666"/>
              </a:xfrm>
            </p:grpSpPr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79CAB193-F76F-48D8-9BEF-551C7C354319}"/>
                    </a:ext>
                  </a:extLst>
                </p:cNvPr>
                <p:cNvSpPr txBox="1"/>
                <p:nvPr/>
              </p:nvSpPr>
              <p:spPr>
                <a:xfrm>
                  <a:off x="2227518" y="3659427"/>
                  <a:ext cx="220626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G (n = 103)  Median 12.5 months (95% CI: 10.8 – 13.97)</a:t>
                  </a:r>
                </a:p>
              </p:txBody>
            </p:sp>
            <p:cxnSp>
              <p:nvCxnSpPr>
                <p:cNvPr id="41" name="Straight Connector 40">
                  <a:extLst>
                    <a:ext uri="{FF2B5EF4-FFF2-40B4-BE49-F238E27FC236}">
                      <a16:creationId xmlns:a16="http://schemas.microsoft.com/office/drawing/2014/main" id="{6FD16C36-94E9-43EF-8B25-6ACACF2FEC0B}"/>
                    </a:ext>
                  </a:extLst>
                </p:cNvPr>
                <p:cNvCxnSpPr/>
                <p:nvPr/>
              </p:nvCxnSpPr>
              <p:spPr>
                <a:xfrm>
                  <a:off x="2785958" y="3706335"/>
                  <a:ext cx="0" cy="91440"/>
                </a:xfrm>
                <a:prstGeom prst="line">
                  <a:avLst/>
                </a:prstGeom>
                <a:ln w="63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D131064-99CC-4104-B89C-5A2AB4662829}"/>
                </a:ext>
              </a:extLst>
            </p:cNvPr>
            <p:cNvSpPr txBox="1"/>
            <p:nvPr/>
          </p:nvSpPr>
          <p:spPr>
            <a:xfrm>
              <a:off x="1709644" y="3352701"/>
              <a:ext cx="52206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Genotype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04478E8D-A852-4B75-A3F8-CA0D5BBD666A}"/>
              </a:ext>
            </a:extLst>
          </p:cNvPr>
          <p:cNvSpPr txBox="1"/>
          <p:nvPr/>
        </p:nvSpPr>
        <p:spPr>
          <a:xfrm>
            <a:off x="5628874" y="277226"/>
            <a:ext cx="18884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iological Sex: Male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39ACAAEE-2168-4A11-9DBB-852FDCA022D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330" t="6706" r="1107"/>
          <a:stretch/>
        </p:blipFill>
        <p:spPr>
          <a:xfrm>
            <a:off x="8691193" y="466390"/>
            <a:ext cx="3500807" cy="2133602"/>
          </a:xfrm>
          <a:prstGeom prst="rect">
            <a:avLst/>
          </a:prstGeom>
        </p:spPr>
      </p:pic>
      <p:grpSp>
        <p:nvGrpSpPr>
          <p:cNvPr id="52" name="Group 51">
            <a:extLst>
              <a:ext uri="{FF2B5EF4-FFF2-40B4-BE49-F238E27FC236}">
                <a16:creationId xmlns:a16="http://schemas.microsoft.com/office/drawing/2014/main" id="{2C29E149-63A8-42C3-99DC-C33E9EE4FA3E}"/>
              </a:ext>
            </a:extLst>
          </p:cNvPr>
          <p:cNvGrpSpPr/>
          <p:nvPr/>
        </p:nvGrpSpPr>
        <p:grpSpPr>
          <a:xfrm>
            <a:off x="9054871" y="2691071"/>
            <a:ext cx="2773449" cy="442382"/>
            <a:chOff x="1709644" y="3216584"/>
            <a:chExt cx="2773449" cy="442382"/>
          </a:xfrm>
        </p:grpSpPr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634871FF-1F63-4D26-90B2-BFFD88AFA8FE}"/>
                </a:ext>
              </a:extLst>
            </p:cNvPr>
            <p:cNvGrpSpPr/>
            <p:nvPr/>
          </p:nvGrpSpPr>
          <p:grpSpPr>
            <a:xfrm>
              <a:off x="2187295" y="3216584"/>
              <a:ext cx="2295798" cy="184654"/>
              <a:chOff x="2187295" y="3009014"/>
              <a:chExt cx="2295798" cy="184654"/>
            </a:xfrm>
          </p:grpSpPr>
          <p:cxnSp>
            <p:nvCxnSpPr>
              <p:cNvPr id="65" name="Straight Connector 64">
                <a:extLst>
                  <a:ext uri="{FF2B5EF4-FFF2-40B4-BE49-F238E27FC236}">
                    <a16:creationId xmlns:a16="http://schemas.microsoft.com/office/drawing/2014/main" id="{31FAB053-8BFB-4E15-A014-17AB137F4C1E}"/>
                  </a:ext>
                </a:extLst>
              </p:cNvPr>
              <p:cNvCxnSpPr/>
              <p:nvPr/>
            </p:nvCxnSpPr>
            <p:spPr>
              <a:xfrm>
                <a:off x="2187295" y="3099676"/>
                <a:ext cx="137160" cy="0"/>
              </a:xfrm>
              <a:prstGeom prst="line">
                <a:avLst/>
              </a:prstGeom>
              <a:ln w="15875">
                <a:solidFill>
                  <a:srgbClr val="90E53B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6" name="Group 65">
                <a:extLst>
                  <a:ext uri="{FF2B5EF4-FFF2-40B4-BE49-F238E27FC236}">
                    <a16:creationId xmlns:a16="http://schemas.microsoft.com/office/drawing/2014/main" id="{705DDFB0-BC9F-4027-80CB-43135536386D}"/>
                  </a:ext>
                </a:extLst>
              </p:cNvPr>
              <p:cNvGrpSpPr/>
              <p:nvPr/>
            </p:nvGrpSpPr>
            <p:grpSpPr>
              <a:xfrm>
                <a:off x="2276834" y="3009014"/>
                <a:ext cx="2206259" cy="184654"/>
                <a:chOff x="2248785" y="3009014"/>
                <a:chExt cx="2206259" cy="184654"/>
              </a:xfrm>
            </p:grpSpPr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A3B3D06B-97F6-4E78-B399-2AFEB93DAACF}"/>
                    </a:ext>
                  </a:extLst>
                </p:cNvPr>
                <p:cNvSpPr txBox="1"/>
                <p:nvPr/>
              </p:nvSpPr>
              <p:spPr>
                <a:xfrm>
                  <a:off x="2248785" y="3009014"/>
                  <a:ext cx="2206259" cy="1846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A (n = 99)  Median 12.33 months (95% CI: 9.7 – 16.07)</a:t>
                  </a:r>
                </a:p>
              </p:txBody>
            </p:sp>
            <p:cxnSp>
              <p:nvCxnSpPr>
                <p:cNvPr id="68" name="Straight Connector 67">
                  <a:extLst>
                    <a:ext uri="{FF2B5EF4-FFF2-40B4-BE49-F238E27FC236}">
                      <a16:creationId xmlns:a16="http://schemas.microsoft.com/office/drawing/2014/main" id="{B2DD0C1E-19A2-4BFB-A810-623EC9026992}"/>
                    </a:ext>
                  </a:extLst>
                </p:cNvPr>
                <p:cNvCxnSpPr/>
                <p:nvPr/>
              </p:nvCxnSpPr>
              <p:spPr>
                <a:xfrm>
                  <a:off x="2744873" y="3054796"/>
                  <a:ext cx="0" cy="91440"/>
                </a:xfrm>
                <a:prstGeom prst="line">
                  <a:avLst/>
                </a:prstGeom>
                <a:ln w="63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299E40E2-6798-4AF3-8949-F3DF45048C6E}"/>
                </a:ext>
              </a:extLst>
            </p:cNvPr>
            <p:cNvGrpSpPr/>
            <p:nvPr/>
          </p:nvGrpSpPr>
          <p:grpSpPr>
            <a:xfrm>
              <a:off x="2188539" y="3349255"/>
              <a:ext cx="2211215" cy="184652"/>
              <a:chOff x="2188539" y="3349255"/>
              <a:chExt cx="2211215" cy="184652"/>
            </a:xfrm>
          </p:grpSpPr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id="{38A8B858-81F4-46B0-91AF-5B72622FF111}"/>
                  </a:ext>
                </a:extLst>
              </p:cNvPr>
              <p:cNvCxnSpPr/>
              <p:nvPr/>
            </p:nvCxnSpPr>
            <p:spPr>
              <a:xfrm>
                <a:off x="2188539" y="3436666"/>
                <a:ext cx="137160" cy="0"/>
              </a:xfrm>
              <a:prstGeom prst="line">
                <a:avLst/>
              </a:prstGeom>
              <a:ln w="15875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2" name="Group 61">
                <a:extLst>
                  <a:ext uri="{FF2B5EF4-FFF2-40B4-BE49-F238E27FC236}">
                    <a16:creationId xmlns:a16="http://schemas.microsoft.com/office/drawing/2014/main" id="{4D847D32-EFD2-4E24-AAAC-AE7F8E0C5C3F}"/>
                  </a:ext>
                </a:extLst>
              </p:cNvPr>
              <p:cNvGrpSpPr/>
              <p:nvPr/>
            </p:nvGrpSpPr>
            <p:grpSpPr>
              <a:xfrm>
                <a:off x="2276836" y="3349255"/>
                <a:ext cx="2122918" cy="184652"/>
                <a:chOff x="2248785" y="3349255"/>
                <a:chExt cx="2122918" cy="184652"/>
              </a:xfrm>
            </p:grpSpPr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2ECB886E-8F7C-4817-9953-AFFA2BA38C56}"/>
                    </a:ext>
                  </a:extLst>
                </p:cNvPr>
                <p:cNvSpPr txBox="1"/>
                <p:nvPr/>
              </p:nvSpPr>
              <p:spPr>
                <a:xfrm>
                  <a:off x="2248785" y="3349255"/>
                  <a:ext cx="2122918" cy="18465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G (n = 25)  Median 15.57 months (95% CI: 7.5 – 22.2)</a:t>
                  </a:r>
                </a:p>
              </p:txBody>
            </p:sp>
            <p:cxnSp>
              <p:nvCxnSpPr>
                <p:cNvPr id="64" name="Straight Connector 63">
                  <a:extLst>
                    <a:ext uri="{FF2B5EF4-FFF2-40B4-BE49-F238E27FC236}">
                      <a16:creationId xmlns:a16="http://schemas.microsoft.com/office/drawing/2014/main" id="{A7F9AB02-F0E8-48C9-B11B-80AF6CB33FB1}"/>
                    </a:ext>
                  </a:extLst>
                </p:cNvPr>
                <p:cNvCxnSpPr/>
                <p:nvPr/>
              </p:nvCxnSpPr>
              <p:spPr>
                <a:xfrm>
                  <a:off x="2757190" y="3389727"/>
                  <a:ext cx="0" cy="91440"/>
                </a:xfrm>
                <a:prstGeom prst="line">
                  <a:avLst/>
                </a:prstGeom>
                <a:ln w="63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719F72AC-72E2-46BC-8DA0-00168659C699}"/>
                </a:ext>
              </a:extLst>
            </p:cNvPr>
            <p:cNvGrpSpPr/>
            <p:nvPr/>
          </p:nvGrpSpPr>
          <p:grpSpPr>
            <a:xfrm>
              <a:off x="2187642" y="3474300"/>
              <a:ext cx="2291016" cy="184666"/>
              <a:chOff x="2187642" y="3659427"/>
              <a:chExt cx="2291016" cy="184666"/>
            </a:xfrm>
          </p:grpSpPr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id="{7EE0E901-A4F2-406C-849E-9CD4AD7923B9}"/>
                  </a:ext>
                </a:extLst>
              </p:cNvPr>
              <p:cNvCxnSpPr/>
              <p:nvPr/>
            </p:nvCxnSpPr>
            <p:spPr>
              <a:xfrm>
                <a:off x="2187642" y="3742360"/>
                <a:ext cx="137160" cy="0"/>
              </a:xfrm>
              <a:prstGeom prst="lin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8" name="Group 57">
                <a:extLst>
                  <a:ext uri="{FF2B5EF4-FFF2-40B4-BE49-F238E27FC236}">
                    <a16:creationId xmlns:a16="http://schemas.microsoft.com/office/drawing/2014/main" id="{2246D30A-00B8-471B-A0CB-A84EFC9664A0}"/>
                  </a:ext>
                </a:extLst>
              </p:cNvPr>
              <p:cNvGrpSpPr/>
              <p:nvPr/>
            </p:nvGrpSpPr>
            <p:grpSpPr>
              <a:xfrm>
                <a:off x="2272398" y="3659427"/>
                <a:ext cx="2206260" cy="184666"/>
                <a:chOff x="2227518" y="3659427"/>
                <a:chExt cx="2206260" cy="184666"/>
              </a:xfrm>
            </p:grpSpPr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B6FDA984-C52C-4A52-874C-FFEEC93F0DD9}"/>
                    </a:ext>
                  </a:extLst>
                </p:cNvPr>
                <p:cNvSpPr txBox="1"/>
                <p:nvPr/>
              </p:nvSpPr>
              <p:spPr>
                <a:xfrm>
                  <a:off x="2227518" y="3659427"/>
                  <a:ext cx="220626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G (n = 60)  Median 13.03 months (95% CI: 8.13 – 16.6)</a:t>
                  </a:r>
                </a:p>
              </p:txBody>
            </p:sp>
            <p:cxnSp>
              <p:nvCxnSpPr>
                <p:cNvPr id="60" name="Straight Connector 59">
                  <a:extLst>
                    <a:ext uri="{FF2B5EF4-FFF2-40B4-BE49-F238E27FC236}">
                      <a16:creationId xmlns:a16="http://schemas.microsoft.com/office/drawing/2014/main" id="{F247CF6E-E2B7-459E-9312-C123F9C3B3F4}"/>
                    </a:ext>
                  </a:extLst>
                </p:cNvPr>
                <p:cNvCxnSpPr/>
                <p:nvPr/>
              </p:nvCxnSpPr>
              <p:spPr>
                <a:xfrm>
                  <a:off x="2742619" y="3706335"/>
                  <a:ext cx="0" cy="91440"/>
                </a:xfrm>
                <a:prstGeom prst="line">
                  <a:avLst/>
                </a:prstGeom>
                <a:ln w="63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C114E91A-169E-4DEF-84DB-6D7BA85653E0}"/>
                </a:ext>
              </a:extLst>
            </p:cNvPr>
            <p:cNvSpPr txBox="1"/>
            <p:nvPr/>
          </p:nvSpPr>
          <p:spPr>
            <a:xfrm>
              <a:off x="1709644" y="3352701"/>
              <a:ext cx="52206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Genotype</a:t>
              </a:r>
            </a:p>
          </p:txBody>
        </p:sp>
      </p:grpSp>
      <p:sp>
        <p:nvSpPr>
          <p:cNvPr id="69" name="TextBox 68">
            <a:extLst>
              <a:ext uri="{FF2B5EF4-FFF2-40B4-BE49-F238E27FC236}">
                <a16:creationId xmlns:a16="http://schemas.microsoft.com/office/drawing/2014/main" id="{32875B13-D206-4054-863D-B5B4F8A97FCC}"/>
              </a:ext>
            </a:extLst>
          </p:cNvPr>
          <p:cNvSpPr txBox="1"/>
          <p:nvPr/>
        </p:nvSpPr>
        <p:spPr>
          <a:xfrm>
            <a:off x="263631" y="6899604"/>
            <a:ext cx="12274338" cy="600164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100" b="1">
                <a:latin typeface="Arial" panose="020B0604020202020204" pitchFamily="34" charset="0"/>
                <a:cs typeface="Times New Roman" panose="02020603050405020304" pitchFamily="18" charset="0"/>
              </a:rPr>
              <a:t>Figure 6: Overall Survival </a:t>
            </a:r>
            <a:r>
              <a:rPr lang="en-US" sz="1100" b="1" dirty="0">
                <a:latin typeface="Arial" panose="020B06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1100" b="1">
                <a:latin typeface="Arial" panose="020B0604020202020204" pitchFamily="34" charset="0"/>
                <a:cs typeface="Times New Roman" panose="02020603050405020304" pitchFamily="18" charset="0"/>
              </a:rPr>
              <a:t>urves </a:t>
            </a:r>
            <a:r>
              <a:rPr lang="en-US" sz="1100" b="1" dirty="0">
                <a:latin typeface="Arial" panose="020B0604020202020204" pitchFamily="34" charset="0"/>
                <a:cs typeface="Times New Roman" panose="02020603050405020304" pitchFamily="18" charset="0"/>
              </a:rPr>
              <a:t>in </a:t>
            </a:r>
            <a:r>
              <a:rPr lang="en-US" sz="1100" b="1">
                <a:latin typeface="Arial" panose="020B0604020202020204" pitchFamily="34" charset="0"/>
                <a:cs typeface="Times New Roman" panose="02020603050405020304" pitchFamily="18" charset="0"/>
              </a:rPr>
              <a:t>the Carriers </a:t>
            </a:r>
            <a:r>
              <a:rPr lang="en-US" sz="1100" b="1" dirty="0">
                <a:latin typeface="Arial" panose="020B0604020202020204" pitchFamily="34" charset="0"/>
                <a:cs typeface="Times New Roman" panose="02020603050405020304" pitchFamily="18" charset="0"/>
              </a:rPr>
              <a:t>of the TSPO </a:t>
            </a:r>
            <a:r>
              <a:rPr lang="en-US" sz="1100" b="1">
                <a:latin typeface="Arial" panose="020B0604020202020204" pitchFamily="34" charset="0"/>
                <a:cs typeface="Times New Roman" panose="02020603050405020304" pitchFamily="18" charset="0"/>
              </a:rPr>
              <a:t>rs6971 Polymorphism </a:t>
            </a:r>
            <a:r>
              <a:rPr lang="en-US" sz="1100" b="1" dirty="0">
                <a:latin typeface="Arial" panose="020B0604020202020204" pitchFamily="34" charset="0"/>
                <a:cs typeface="Times New Roman" panose="02020603050405020304" pitchFamily="18" charset="0"/>
              </a:rPr>
              <a:t>S</a:t>
            </a:r>
            <a:r>
              <a:rPr lang="en-US" sz="1100" b="1">
                <a:latin typeface="Arial" panose="020B0604020202020204" pitchFamily="34" charset="0"/>
                <a:cs typeface="Times New Roman" panose="02020603050405020304" pitchFamily="18" charset="0"/>
              </a:rPr>
              <a:t>tratified by Genotype and Biological </a:t>
            </a:r>
            <a:r>
              <a:rPr lang="en-US" sz="1100" b="1" dirty="0">
                <a:latin typeface="Arial" panose="020B0604020202020204" pitchFamily="34" charset="0"/>
                <a:cs typeface="Times New Roman" panose="02020603050405020304" pitchFamily="18" charset="0"/>
              </a:rPr>
              <a:t>S</a:t>
            </a:r>
            <a:r>
              <a:rPr lang="en-US" sz="1100" b="1">
                <a:latin typeface="Arial" panose="020B0604020202020204" pitchFamily="34" charset="0"/>
                <a:cs typeface="Times New Roman" panose="02020603050405020304" pitchFamily="18" charset="0"/>
              </a:rPr>
              <a:t>ex</a:t>
            </a:r>
            <a:r>
              <a:rPr lang="en-US" sz="1100" b="1" dirty="0">
                <a:latin typeface="Arial" panose="020B0604020202020204" pitchFamily="34" charset="0"/>
                <a:cs typeface="Times New Roman" panose="02020603050405020304" pitchFamily="18" charset="0"/>
              </a:rPr>
              <a:t>, using the TCGA-GBM dataset. </a:t>
            </a:r>
            <a:r>
              <a:rPr lang="en-US" sz="1100" dirty="0">
                <a:latin typeface="Arial" panose="020B0604020202020204" pitchFamily="34" charset="0"/>
                <a:cs typeface="Times New Roman" panose="02020603050405020304" pitchFamily="18" charset="0"/>
              </a:rPr>
              <a:t>Overall survival probability curves in the entire population (left panel), male subgroup (middle panel), and female subgroup (right panel) comparing the wild-type A/A, heterozygous A/G, and variant G/G genotypes for the TSPO rs6971 polymorphism using the patient data from the TCGA-GBM database. Genotype patient numbers and statistical analysis are indicated in each graph.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5B74E96-75E5-4D70-AC48-9B7544CC3F43}"/>
              </a:ext>
            </a:extLst>
          </p:cNvPr>
          <p:cNvSpPr txBox="1"/>
          <p:nvPr/>
        </p:nvSpPr>
        <p:spPr>
          <a:xfrm>
            <a:off x="9703052" y="280981"/>
            <a:ext cx="18884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iological sex: Female</a:t>
            </a:r>
          </a:p>
        </p:txBody>
      </p:sp>
    </p:spTree>
    <p:extLst>
      <p:ext uri="{BB962C8B-B14F-4D97-AF65-F5344CB8AC3E}">
        <p14:creationId xmlns:p14="http://schemas.microsoft.com/office/powerpoint/2010/main" val="1266539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5</TotalTime>
  <Words>273</Words>
  <Application>Microsoft Office PowerPoint</Application>
  <PresentationFormat>Custom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let Maria Acanda De La Rocha</dc:creator>
  <cp:lastModifiedBy>Diana Azzam</cp:lastModifiedBy>
  <cp:revision>30</cp:revision>
  <dcterms:created xsi:type="dcterms:W3CDTF">2021-04-29T20:42:05Z</dcterms:created>
  <dcterms:modified xsi:type="dcterms:W3CDTF">2021-08-27T01:19:23Z</dcterms:modified>
</cp:coreProperties>
</file>